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283EB-6F2E-4BBE-B782-D21A4C172F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ADC0C-F4C7-4610-A662-66FE810ED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F6A5C-7CB9-4DC4-90D5-4A252859A7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ACD07-444A-41E5-B7D0-1C85C5A20C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C188C-78CF-40F3-9E1F-AD2575D11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98AC3-CC2C-4177-B65E-1DC04CA08E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35B9D-FAF5-4C12-A017-43FA500216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BC3F9-BA5C-48A4-AC70-96C8D86E67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AFF01-2DBD-4B0C-B683-A53B397C57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B8F72-D439-4469-82BB-E84EDEB6B0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3B87D-11C0-4007-9B9C-E8351345DF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A96FC-7861-4F3F-944C-BF93B0230E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07ED64-B325-4EE2-B8F8-9B62E7CC107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1.jpeg"/><Relationship Id="rId5" Type="http://schemas.openxmlformats.org/officeDocument/2006/relationships/image" Target="../media/image4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ontent Placeholder 3" descr="C:\Users\dell\Desktop\HGVOproject\20141104_180304.jpg"/>
          <p:cNvPicPr/>
          <p:nvPr/>
        </p:nvPicPr>
        <p:blipFill>
          <a:blip r:embed="rId1"/>
          <a:srcRect l="34933" t="30390" r="41916" b="30390"/>
          <a:stretch/>
        </p:blipFill>
        <p:spPr>
          <a:xfrm>
            <a:off x="7151760" y="2146320"/>
            <a:ext cx="1676160" cy="2133720"/>
          </a:xfrm>
          <a:prstGeom prst="rect">
            <a:avLst/>
          </a:prstGeom>
          <a:ln w="0">
            <a:noFill/>
          </a:ln>
        </p:spPr>
      </p:pic>
      <p:pic>
        <p:nvPicPr>
          <p:cNvPr id="42" name="Content Placeholder 5" descr="C:\Users\dell\Desktop\HGVOproject\20141013_173330.jpg"/>
          <p:cNvPicPr/>
          <p:nvPr/>
        </p:nvPicPr>
        <p:blipFill>
          <a:blip r:embed="rId2"/>
          <a:srcRect l="39698" t="33333" r="29773" b="16667"/>
          <a:stretch/>
        </p:blipFill>
        <p:spPr>
          <a:xfrm>
            <a:off x="314280" y="2135160"/>
            <a:ext cx="1676520" cy="2133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C:\Users\dell\Desktop\HGVOproject\20141018_113527.jpg"/>
          <p:cNvPicPr/>
          <p:nvPr/>
        </p:nvPicPr>
        <p:blipFill>
          <a:blip r:embed="rId3"/>
          <a:srcRect l="0" t="13342" r="68313" b="22222"/>
          <a:stretch/>
        </p:blipFill>
        <p:spPr>
          <a:xfrm>
            <a:off x="2023920" y="2133720"/>
            <a:ext cx="1675080" cy="2144520"/>
          </a:xfrm>
          <a:prstGeom prst="rect">
            <a:avLst/>
          </a:prstGeom>
          <a:ln w="0">
            <a:noFill/>
          </a:ln>
        </p:spPr>
      </p:pic>
      <p:pic>
        <p:nvPicPr>
          <p:cNvPr id="44" name="Content Placeholder 3" descr="C:\Users\dell\Desktop\HGVOproject\20141104_180304.jpg"/>
          <p:cNvPicPr/>
          <p:nvPr/>
        </p:nvPicPr>
        <p:blipFill>
          <a:blip r:embed="rId4"/>
          <a:srcRect l="59376" t="36468" r="0" b="6078"/>
          <a:stretch/>
        </p:blipFill>
        <p:spPr>
          <a:xfrm>
            <a:off x="3732120" y="2138400"/>
            <a:ext cx="1671840" cy="2133720"/>
          </a:xfrm>
          <a:prstGeom prst="rect">
            <a:avLst/>
          </a:prstGeom>
          <a:ln w="0">
            <a:noFill/>
          </a:ln>
        </p:spPr>
      </p:pic>
      <p:pic>
        <p:nvPicPr>
          <p:cNvPr id="45" name="Content Placeholder 3" descr="C:\Users\dell\Desktop\Phdfolder\20141204_134315.jpg"/>
          <p:cNvPicPr/>
          <p:nvPr/>
        </p:nvPicPr>
        <p:blipFill>
          <a:blip r:embed="rId5"/>
          <a:srcRect l="50340" t="22312" r="3595" b="35699"/>
          <a:stretch/>
        </p:blipFill>
        <p:spPr>
          <a:xfrm>
            <a:off x="5430960" y="2141640"/>
            <a:ext cx="1687320" cy="2133360"/>
          </a:xfrm>
          <a:prstGeom prst="rect">
            <a:avLst/>
          </a:prstGeom>
          <a:ln w="0">
            <a:noFill/>
          </a:ln>
        </p:spPr>
      </p:pic>
      <p:sp>
        <p:nvSpPr>
          <p:cNvPr id="46" name="TextBox 16"/>
          <p:cNvSpPr/>
          <p:nvPr/>
        </p:nvSpPr>
        <p:spPr>
          <a:xfrm>
            <a:off x="609480" y="4419720"/>
            <a:ext cx="129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eginning of the cultu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6"/>
          <p:cNvSpPr/>
          <p:nvPr/>
        </p:nvSpPr>
        <p:spPr>
          <a:xfrm>
            <a:off x="2260440" y="44337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fter 16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6"/>
          <p:cNvSpPr/>
          <p:nvPr/>
        </p:nvSpPr>
        <p:spPr>
          <a:xfrm>
            <a:off x="3962520" y="44308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fter 23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6"/>
          <p:cNvSpPr/>
          <p:nvPr/>
        </p:nvSpPr>
        <p:spPr>
          <a:xfrm>
            <a:off x="5649840" y="44308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fter 39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6"/>
          <p:cNvSpPr/>
          <p:nvPr/>
        </p:nvSpPr>
        <p:spPr>
          <a:xfrm>
            <a:off x="7467480" y="4433760"/>
            <a:ext cx="1371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biotic control after 39 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"/>
          <p:cNvSpPr/>
          <p:nvPr/>
        </p:nvSpPr>
        <p:spPr>
          <a:xfrm>
            <a:off x="3851640" y="9144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10T07:58:26Z</dcterms:created>
  <dc:creator>waelame</dc:creator>
  <dc:description/>
  <dc:language>en-US</dc:language>
  <cp:lastModifiedBy>Wael Ahmed Ismail Elmoslimany</cp:lastModifiedBy>
  <dcterms:modified xsi:type="dcterms:W3CDTF">2017-04-12T09:48:14Z</dcterms:modified>
  <cp:revision>10</cp:revision>
  <dc:subject/>
  <dc:title>Slide 1</dc:title>
</cp:coreProperties>
</file>